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F1EC945A-A4DF-1F4E-9F23-B4363DFB3812}" name="Yixin Tang" initials="YT" userId="S::Yixin.Tang@UTSouthwestern.edu::3ac8cd48-f3da-4835-a0a5-afeea6e17dcc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114" y="1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5E98EE-1643-44D9-AF17-2FCBB99FA72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6DE3CA3-8E79-47CE-B4AC-893E8605DC7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C85504-D299-40EA-A586-B2DBF2FAFC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8DE5CF-F929-4D71-8786-6A39D528B053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8099A6-06B6-4885-8F73-DDB4DA43F2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491B6C-DBF7-493A-A2E1-C078EA1500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D3F4F-1F2D-4BC9-95DB-03967A24D0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43552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7CDBA2-7B4A-44CE-B605-4699DA1275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784C2B9-BB23-46F0-B232-B05C1458EC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1E05C4-31BE-4837-8DB9-50ECBAC30F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8DE5CF-F929-4D71-8786-6A39D528B053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6A116D-F9AF-405D-9470-77C629E9D0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D3075B-DD34-456B-8AE2-9F3EFCD459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D3F4F-1F2D-4BC9-95DB-03967A24D0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19214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B75286D-FB9F-440D-8272-1E9E4115FFE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364C941-358A-45B6-818D-FA1AEC246C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94D673-8CDE-49F5-A39B-C470023EC0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8DE5CF-F929-4D71-8786-6A39D528B053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DB42FE-2026-4FBA-8F77-1E296FC59A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DB3595-1DDE-41FD-AC09-F90C010AE9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D3F4F-1F2D-4BC9-95DB-03967A24D0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27403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52BDBB-C6AF-4AD2-8B5A-DA58B4DD06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DF3079-5085-4FA4-A2DA-DEE450771AD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11E183-C5AF-488A-9933-AA3E9AD199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8DE5CF-F929-4D71-8786-6A39D528B053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F24230-BEE9-48C2-90F0-3D1717BFBE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54FF1B-7D42-4519-A0BA-6BD1C694DB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D3F4F-1F2D-4BC9-95DB-03967A24D0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28602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42D666-5593-476B-A7DC-6240D560DA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2FDF31A-DECE-40EE-BFEB-42F4EA4DC3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2D8F92-EFCF-4D8C-8A37-33F403226B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8DE5CF-F929-4D71-8786-6A39D528B053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DBA8CA-382F-48ED-BBF4-401A47F7E0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A0AE2A-12DB-476A-BE94-4037E74969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D3F4F-1F2D-4BC9-95DB-03967A24D0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36187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8A60BD-951D-4CF4-9ED4-1E33652B00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B6EFC7-0FFA-4E59-BD25-37A5697EED4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546B613-B1C0-42B7-B232-CC2EE81B45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9A234DB-01E2-44B8-B49C-3A4494707A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8DE5CF-F929-4D71-8786-6A39D528B053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C28A882-5CFC-499C-827F-B8921C5E2F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8709B9B-11F8-4BA2-909B-CC6E7EE9CB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D3F4F-1F2D-4BC9-95DB-03967A24D0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21548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9F3C95-43F9-45B4-BC1B-EB83A72FB1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37F22F9-3F01-442D-B13A-EB2AFF69DE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47BE08D-C479-4B91-A843-093014906E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187E5E9-BB4D-4933-9666-BB087823270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13D7674-8FBE-41F9-8D1D-AC7CB2BB5AC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ACF42A4-C24D-4EB0-9E17-E1FAE3F49C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8DE5CF-F929-4D71-8786-6A39D528B053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80DF7FB-36EA-41D6-883D-4D12EF3C8F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462C4C6-2AA7-4B1D-A36E-65045EE763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D3F4F-1F2D-4BC9-95DB-03967A24D0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8517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378E16-16E2-4C2E-BC68-7B893490A0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BE03ECD-A5E4-405F-AFF7-20BD7DB6DC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8DE5CF-F929-4D71-8786-6A39D528B053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259CF8A-1CC2-43B1-81EB-342D508457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4BC26AA-2FB1-4727-A082-84CBF1D01B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D3F4F-1F2D-4BC9-95DB-03967A24D0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96863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33EACAE-FF77-4855-9890-68C036F0EF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8DE5CF-F929-4D71-8786-6A39D528B053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D58F82B-3137-4AEC-826F-54896721ED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C12EE04-25D9-4C04-B18C-06B28C9164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D3F4F-1F2D-4BC9-95DB-03967A24D0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054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CD0781-4E6A-423E-AF8F-C8F63C7284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6FBE21-83A2-4BE6-AD0F-7DB5E2518C5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5380093-29D4-4A55-BC2C-99F2F5ECAD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618164-05F0-4807-98CD-A362CF52EF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8DE5CF-F929-4D71-8786-6A39D528B053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1A2ACB-946B-48AC-A888-53968CA72E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EA80A4D-5D8E-460B-968A-EDB9057625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D3F4F-1F2D-4BC9-95DB-03967A24D0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87520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45D9E6-A8D7-43E9-A906-7ECDFD93D6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A188521-391D-4EF0-B6B1-E20912F91C5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19B5345-41F1-4B42-8497-424BE3652EA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1AA97B-7B37-412D-8FFE-071C014FCE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8DE5CF-F929-4D71-8786-6A39D528B053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5AC070A-3B3C-436F-843A-3BD6A66975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1570EB4-E13A-4391-8A71-C93BA9CD9F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D3F4F-1F2D-4BC9-95DB-03967A24D0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5421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E765CBA-F685-4C72-84E1-E428B10358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EB1F9E-6294-4965-A344-4A14821866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D95025-F0E2-4000-ACE0-16CD0D5FB90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8DE5CF-F929-4D71-8786-6A39D528B053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CCACDD-2F8C-4833-8788-27B314F6CC2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CE03A0-8D33-452D-8E8B-4863C72D354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8D3F4F-1F2D-4BC9-95DB-03967A24D0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52404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Rectangle 22">
            <a:extLst>
              <a:ext uri="{FF2B5EF4-FFF2-40B4-BE49-F238E27FC236}">
                <a16:creationId xmlns:a16="http://schemas.microsoft.com/office/drawing/2014/main" id="{D05CCE56-285E-497C-8C56-0B041B3C0031}"/>
              </a:ext>
            </a:extLst>
          </p:cNvPr>
          <p:cNvSpPr/>
          <p:nvPr/>
        </p:nvSpPr>
        <p:spPr>
          <a:xfrm>
            <a:off x="4158858" y="2152130"/>
            <a:ext cx="3895228" cy="142311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tients who underwent one of the hand surgical procedures between 2019-2022 procedure in ambulatory surgery center, hospital outpatient department, or inpatient hospital. Keep only the earliest episode per patient.</a:t>
            </a:r>
          </a:p>
          <a:p>
            <a:pPr marL="228600" indent="-228600">
              <a:buAutoNum type="arabicPeriod"/>
            </a:pP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RIF of distal radius fracture</a:t>
            </a:r>
          </a:p>
          <a:p>
            <a:pPr marL="228600" indent="-228600">
              <a:buAutoNum type="arabicPeriod"/>
            </a:pP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lexor Tendon Repair</a:t>
            </a:r>
          </a:p>
          <a:p>
            <a:pPr marL="228600" indent="-228600">
              <a:buAutoNum type="arabicPeriod"/>
            </a:pP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vascularization/Replantation</a:t>
            </a:r>
          </a:p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= 23,606)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4DB86B35-98F3-461B-83A6-9B1B784DF9FA}"/>
              </a:ext>
            </a:extLst>
          </p:cNvPr>
          <p:cNvSpPr/>
          <p:nvPr/>
        </p:nvSpPr>
        <p:spPr>
          <a:xfrm>
            <a:off x="8443362" y="967103"/>
            <a:ext cx="3357209" cy="52707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12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GE</a:t>
            </a:r>
          </a:p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utpatients age &lt;18 at time of  1</a:t>
            </a:r>
            <a:r>
              <a:rPr lang="en-US" sz="1200" baseline="30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episode or ≥ 65 (N=44)</a:t>
            </a:r>
          </a:p>
          <a:p>
            <a:endParaRPr lang="en-US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PENDING</a:t>
            </a:r>
          </a:p>
          <a:p>
            <a:r>
              <a:rPr lang="en-US" sz="12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rgery &amp; 90 Day Episode</a:t>
            </a:r>
            <a:endParaRPr lang="en-US" sz="12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utpatients with negative total payments (N=5)</a:t>
            </a:r>
          </a:p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utpatients with zero total payments (N=66)</a:t>
            </a:r>
          </a:p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utpatients with negative OOP expenses (N=2)</a:t>
            </a:r>
          </a:p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payments 1</a:t>
            </a:r>
            <a:r>
              <a:rPr lang="en-US" sz="1200" baseline="30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&amp; 99</a:t>
            </a:r>
            <a:r>
              <a:rPr lang="en-US" sz="1200" baseline="30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ercentiles (N=420)</a:t>
            </a:r>
          </a:p>
          <a:p>
            <a:r>
              <a:rPr lang="en-US" sz="12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rgery Only</a:t>
            </a:r>
          </a:p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utpatients with negative total payments (N=2)</a:t>
            </a:r>
          </a:p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utpatients with zero total payments (N=22)</a:t>
            </a:r>
          </a:p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payments 1st &amp; 99</a:t>
            </a:r>
            <a:r>
              <a:rPr lang="en-US" sz="1200" baseline="30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ercentiles (N=412)</a:t>
            </a:r>
          </a:p>
          <a:p>
            <a:endParaRPr lang="en-US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TIENTS WITH BOTH INPATIENT &amp; OUTPATIENT EPISODES</a:t>
            </a:r>
          </a:p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mong the 120 patients with both inpatient &amp; outpatient episodes, retain episode with earliest index date. Thus 22 outpatient episodes excluded (N=22)</a:t>
            </a:r>
          </a:p>
          <a:p>
            <a:endParaRPr lang="en-US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SSINGNESS</a:t>
            </a:r>
          </a:p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utpatients with missingness for region or insurance type </a:t>
            </a:r>
          </a:p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=344)</a:t>
            </a:r>
          </a:p>
          <a:p>
            <a:endParaRPr lang="en-US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BF996B45-8587-4173-BE9B-B14A112D111B}"/>
              </a:ext>
            </a:extLst>
          </p:cNvPr>
          <p:cNvCxnSpPr>
            <a:cxnSpLocks/>
          </p:cNvCxnSpPr>
          <p:nvPr/>
        </p:nvCxnSpPr>
        <p:spPr>
          <a:xfrm flipH="1">
            <a:off x="7938655" y="5434878"/>
            <a:ext cx="504707" cy="27699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157B5ECD-9830-419F-AAC8-AE9EE274C5DD}"/>
              </a:ext>
            </a:extLst>
          </p:cNvPr>
          <p:cNvCxnSpPr>
            <a:cxnSpLocks/>
          </p:cNvCxnSpPr>
          <p:nvPr/>
        </p:nvCxnSpPr>
        <p:spPr>
          <a:xfrm>
            <a:off x="7526092" y="4231628"/>
            <a:ext cx="932108" cy="14165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4" name="TextBox 63">
            <a:extLst>
              <a:ext uri="{FF2B5EF4-FFF2-40B4-BE49-F238E27FC236}">
                <a16:creationId xmlns:a16="http://schemas.microsoft.com/office/drawing/2014/main" id="{7EA52FEB-665D-4236-9A59-8D3BAF8A246D}"/>
              </a:ext>
            </a:extLst>
          </p:cNvPr>
          <p:cNvSpPr txBox="1"/>
          <p:nvPr/>
        </p:nvSpPr>
        <p:spPr>
          <a:xfrm>
            <a:off x="7691139" y="4373284"/>
            <a:ext cx="8444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luded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E1B98303-55B0-43E2-8144-BBCEB8C7C461}"/>
              </a:ext>
            </a:extLst>
          </p:cNvPr>
          <p:cNvSpPr txBox="1"/>
          <p:nvPr/>
        </p:nvSpPr>
        <p:spPr>
          <a:xfrm>
            <a:off x="217799" y="267892"/>
            <a:ext cx="331269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Appendix B: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lusion and Exclusion Criteria </a:t>
            </a:r>
          </a:p>
        </p:txBody>
      </p: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BF996B45-8587-4173-BE9B-B14A112D111B}"/>
              </a:ext>
            </a:extLst>
          </p:cNvPr>
          <p:cNvCxnSpPr>
            <a:cxnSpLocks/>
          </p:cNvCxnSpPr>
          <p:nvPr/>
        </p:nvCxnSpPr>
        <p:spPr>
          <a:xfrm flipH="1">
            <a:off x="6077315" y="1889104"/>
            <a:ext cx="2638" cy="23917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Rectangle 33">
            <a:extLst>
              <a:ext uri="{FF2B5EF4-FFF2-40B4-BE49-F238E27FC236}">
                <a16:creationId xmlns:a16="http://schemas.microsoft.com/office/drawing/2014/main" id="{20731728-A629-465D-A734-2FD1CB669250}"/>
              </a:ext>
            </a:extLst>
          </p:cNvPr>
          <p:cNvSpPr/>
          <p:nvPr/>
        </p:nvSpPr>
        <p:spPr>
          <a:xfrm>
            <a:off x="3925800" y="5400803"/>
            <a:ext cx="1320901" cy="50666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patient Cohort (N= 2,276)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04418B47-3FFB-F6B8-101E-76A058603881}"/>
              </a:ext>
            </a:extLst>
          </p:cNvPr>
          <p:cNvSpPr/>
          <p:nvPr/>
        </p:nvSpPr>
        <p:spPr>
          <a:xfrm>
            <a:off x="4684287" y="155394"/>
            <a:ext cx="3006851" cy="8295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tients in </a:t>
            </a:r>
            <a:r>
              <a:rPr lang="en-US" sz="12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rative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rketScan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ommercial Database Annual Summary Enrollment Table (2019-2022)</a:t>
            </a:r>
          </a:p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=41,726,154)</a:t>
            </a:r>
          </a:p>
        </p:txBody>
      </p: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E609EFC1-4CCB-246B-BC26-772148EE10EC}"/>
              </a:ext>
            </a:extLst>
          </p:cNvPr>
          <p:cNvCxnSpPr/>
          <p:nvPr/>
        </p:nvCxnSpPr>
        <p:spPr>
          <a:xfrm flipH="1">
            <a:off x="6077315" y="976477"/>
            <a:ext cx="1482" cy="28380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" name="Rectangle 4">
            <a:extLst>
              <a:ext uri="{FF2B5EF4-FFF2-40B4-BE49-F238E27FC236}">
                <a16:creationId xmlns:a16="http://schemas.microsoft.com/office/drawing/2014/main" id="{AC79CBAF-FC53-DF2F-6DFF-E3A3AB93B822}"/>
              </a:ext>
            </a:extLst>
          </p:cNvPr>
          <p:cNvSpPr/>
          <p:nvPr/>
        </p:nvSpPr>
        <p:spPr>
          <a:xfrm>
            <a:off x="4731156" y="1275468"/>
            <a:ext cx="2791330" cy="5809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tients &lt;18 years or &gt; 65 years (2019-2022)</a:t>
            </a:r>
          </a:p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= 32,782,223) 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F49F3E99-5D4B-DDB0-403B-2503EC5CA0B4}"/>
              </a:ext>
            </a:extLst>
          </p:cNvPr>
          <p:cNvCxnSpPr>
            <a:cxnSpLocks/>
          </p:cNvCxnSpPr>
          <p:nvPr/>
        </p:nvCxnSpPr>
        <p:spPr>
          <a:xfrm>
            <a:off x="3383950" y="5400803"/>
            <a:ext cx="548868" cy="29572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Rectangle 12">
            <a:extLst>
              <a:ext uri="{FF2B5EF4-FFF2-40B4-BE49-F238E27FC236}">
                <a16:creationId xmlns:a16="http://schemas.microsoft.com/office/drawing/2014/main" id="{36933118-86B3-FDBB-4F28-99765E1758A6}"/>
              </a:ext>
            </a:extLst>
          </p:cNvPr>
          <p:cNvSpPr/>
          <p:nvPr/>
        </p:nvSpPr>
        <p:spPr>
          <a:xfrm>
            <a:off x="4475546" y="6251669"/>
            <a:ext cx="2791330" cy="3127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del Cohort (N=22,024)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EEE1D5E8-9075-5373-5668-52BDDB4BF451}"/>
              </a:ext>
            </a:extLst>
          </p:cNvPr>
          <p:cNvSpPr/>
          <p:nvPr/>
        </p:nvSpPr>
        <p:spPr>
          <a:xfrm>
            <a:off x="217799" y="984983"/>
            <a:ext cx="3148496" cy="52666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GE</a:t>
            </a:r>
          </a:p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patients age &lt;18 at time of 1st episode or ≥ 65 (N=4)</a:t>
            </a:r>
          </a:p>
          <a:p>
            <a:endParaRPr lang="en-US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PENDING</a:t>
            </a:r>
          </a:p>
          <a:p>
            <a:r>
              <a:rPr lang="en-US" sz="12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rgery &amp; 90 Day Episode</a:t>
            </a:r>
          </a:p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patients with negative total payments (N=1)</a:t>
            </a:r>
          </a:p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patients with negative OOP expenses (N=3)</a:t>
            </a:r>
          </a:p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payments 1st &amp; 99</a:t>
            </a:r>
            <a:r>
              <a:rPr lang="en-US" sz="1200" baseline="30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ercentiles (N=52)</a:t>
            </a:r>
          </a:p>
          <a:p>
            <a:r>
              <a:rPr lang="en-US" sz="12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rgery Only</a:t>
            </a:r>
          </a:p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payments 1st &amp; 99</a:t>
            </a:r>
            <a:r>
              <a:rPr lang="en-US" sz="1200" baseline="30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ercentiles (N=50)</a:t>
            </a:r>
          </a:p>
          <a:p>
            <a:endParaRPr lang="en-US" sz="1200" b="1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TIENTS WITH BOTH INPATIENT &amp; OUTPATIENT EPISODES</a:t>
            </a:r>
          </a:p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mong the 120 patients with both inpatient &amp; outpatient episodes, retain episode with earliest index date. Thus 98 inpatient episodes excluded (N=98)</a:t>
            </a:r>
          </a:p>
          <a:p>
            <a:endParaRPr lang="en-US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SSINGNESS</a:t>
            </a:r>
          </a:p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patients with missingness for region or insurance type </a:t>
            </a:r>
          </a:p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=35)</a:t>
            </a:r>
          </a:p>
          <a:p>
            <a:endParaRPr lang="en-US" sz="12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5628F5BF-EAB4-F0CC-838B-5F0C5063363C}"/>
              </a:ext>
            </a:extLst>
          </p:cNvPr>
          <p:cNvSpPr/>
          <p:nvPr/>
        </p:nvSpPr>
        <p:spPr>
          <a:xfrm>
            <a:off x="6502013" y="3913083"/>
            <a:ext cx="1708343" cy="3127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utpatients (N= 21,087) </a:t>
            </a: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7142CBAF-3719-B63D-6FBE-615E05BE2212}"/>
              </a:ext>
            </a:extLst>
          </p:cNvPr>
          <p:cNvCxnSpPr>
            <a:cxnSpLocks/>
          </p:cNvCxnSpPr>
          <p:nvPr/>
        </p:nvCxnSpPr>
        <p:spPr>
          <a:xfrm>
            <a:off x="7460846" y="3608052"/>
            <a:ext cx="194081" cy="30503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43D3E221-AE1D-948B-4C90-FA3F21B041DB}"/>
              </a:ext>
            </a:extLst>
          </p:cNvPr>
          <p:cNvCxnSpPr>
            <a:cxnSpLocks/>
          </p:cNvCxnSpPr>
          <p:nvPr/>
        </p:nvCxnSpPr>
        <p:spPr>
          <a:xfrm flipH="1">
            <a:off x="4612747" y="3608052"/>
            <a:ext cx="71540" cy="29606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Rectangle 25">
            <a:extLst>
              <a:ext uri="{FF2B5EF4-FFF2-40B4-BE49-F238E27FC236}">
                <a16:creationId xmlns:a16="http://schemas.microsoft.com/office/drawing/2014/main" id="{659A9444-4527-31A0-69F6-527B27B22D7F}"/>
              </a:ext>
            </a:extLst>
          </p:cNvPr>
          <p:cNvSpPr/>
          <p:nvPr/>
        </p:nvSpPr>
        <p:spPr>
          <a:xfrm>
            <a:off x="3849033" y="3909329"/>
            <a:ext cx="1708343" cy="3127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patients (N= 2,519) </a:t>
            </a:r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5FA94D8E-3DF2-42A1-26D3-4771A2799623}"/>
              </a:ext>
            </a:extLst>
          </p:cNvPr>
          <p:cNvCxnSpPr>
            <a:cxnSpLocks/>
          </p:cNvCxnSpPr>
          <p:nvPr/>
        </p:nvCxnSpPr>
        <p:spPr>
          <a:xfrm flipH="1">
            <a:off x="3355904" y="4222127"/>
            <a:ext cx="802954" cy="18704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34AFFEFA-1A64-46FE-B098-8BE7B52EB129}"/>
              </a:ext>
            </a:extLst>
          </p:cNvPr>
          <p:cNvSpPr txBox="1"/>
          <p:nvPr/>
        </p:nvSpPr>
        <p:spPr>
          <a:xfrm>
            <a:off x="3482805" y="4326046"/>
            <a:ext cx="8444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luded</a:t>
            </a: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30793622-C385-20EE-A042-F9B9DBFB3718}"/>
              </a:ext>
            </a:extLst>
          </p:cNvPr>
          <p:cNvSpPr/>
          <p:nvPr/>
        </p:nvSpPr>
        <p:spPr>
          <a:xfrm>
            <a:off x="6390760" y="5434878"/>
            <a:ext cx="1529427" cy="49676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utpatient Cohort (N= 19,748) </a:t>
            </a:r>
          </a:p>
        </p:txBody>
      </p: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D36D16FD-6258-D7CA-FB8F-38A36134E462}"/>
              </a:ext>
            </a:extLst>
          </p:cNvPr>
          <p:cNvCxnSpPr>
            <a:cxnSpLocks/>
          </p:cNvCxnSpPr>
          <p:nvPr/>
        </p:nvCxnSpPr>
        <p:spPr>
          <a:xfrm>
            <a:off x="4663133" y="5935256"/>
            <a:ext cx="435868" cy="30263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694E2199-B31D-1CDA-A04B-4E29B8EFC721}"/>
              </a:ext>
            </a:extLst>
          </p:cNvPr>
          <p:cNvCxnSpPr>
            <a:cxnSpLocks/>
          </p:cNvCxnSpPr>
          <p:nvPr/>
        </p:nvCxnSpPr>
        <p:spPr>
          <a:xfrm flipH="1">
            <a:off x="6553968" y="5950095"/>
            <a:ext cx="511086" cy="28779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514249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9</TotalTime>
  <Words>389</Words>
  <Application>Microsoft Office PowerPoint</Application>
  <PresentationFormat>Widescreen</PresentationFormat>
  <Paragraphs>5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ssica Billig</dc:creator>
  <cp:lastModifiedBy>Jessica Billig</cp:lastModifiedBy>
  <cp:revision>52</cp:revision>
  <dcterms:created xsi:type="dcterms:W3CDTF">2019-10-10T14:46:24Z</dcterms:created>
  <dcterms:modified xsi:type="dcterms:W3CDTF">2025-07-29T14:31:04Z</dcterms:modified>
</cp:coreProperties>
</file>